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3"/>
    <p:sldId id="259" r:id="rId4"/>
    <p:sldId id="260" r:id="rId5"/>
    <p:sldId id="266" r:id="rId6"/>
    <p:sldId id="265" r:id="rId7"/>
    <p:sldId id="262" r:id="rId8"/>
    <p:sldId id="264" r:id="rId9"/>
  </p:sldIdLst>
  <p:sldSz cx="7559675" cy="1069149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45128" y="1750119"/>
            <a:ext cx="5670768" cy="3723024"/>
          </a:xfrm>
        </p:spPr>
        <p:txBody>
          <a:bodyPr anchor="b"/>
          <a:lstStyle>
            <a:lvl1pPr algn="ctr">
              <a:defRPr sz="495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945128" y="5616717"/>
            <a:ext cx="5670768" cy="2581857"/>
          </a:xfrm>
        </p:spPr>
        <p:txBody>
          <a:bodyPr/>
          <a:lstStyle>
            <a:lvl1pPr marL="0" indent="0" algn="ctr">
              <a:buNone/>
              <a:defRPr sz="1985"/>
            </a:lvl1pPr>
            <a:lvl2pPr marL="378460" indent="0" algn="ctr">
              <a:buNone/>
              <a:defRPr sz="1655"/>
            </a:lvl2pPr>
            <a:lvl3pPr marL="756285" indent="0" algn="ctr">
              <a:buNone/>
              <a:defRPr sz="1490"/>
            </a:lvl3pPr>
            <a:lvl4pPr marL="1134110" indent="0" algn="ctr">
              <a:buNone/>
              <a:defRPr sz="1315"/>
            </a:lvl4pPr>
            <a:lvl5pPr marL="1511935" indent="0" algn="ctr">
              <a:buNone/>
              <a:defRPr sz="1315"/>
            </a:lvl5pPr>
            <a:lvl6pPr marL="1890395" indent="0" algn="ctr">
              <a:buNone/>
              <a:defRPr sz="1315"/>
            </a:lvl6pPr>
            <a:lvl7pPr marL="2268855" indent="0" algn="ctr">
              <a:buNone/>
              <a:defRPr sz="1315"/>
            </a:lvl7pPr>
            <a:lvl8pPr marL="2646045" indent="0" algn="ctr">
              <a:buNone/>
              <a:defRPr sz="1315"/>
            </a:lvl8pPr>
            <a:lvl9pPr marL="3025140" indent="0" algn="ctr">
              <a:buNone/>
              <a:defRPr sz="1315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410858" y="569346"/>
            <a:ext cx="1630346" cy="906249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519821" y="569346"/>
            <a:ext cx="4796525" cy="906249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15883" y="2666024"/>
            <a:ext cx="6521383" cy="4448320"/>
          </a:xfrm>
        </p:spPr>
        <p:txBody>
          <a:bodyPr anchor="b"/>
          <a:lstStyle>
            <a:lvl1pPr>
              <a:defRPr sz="495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15883" y="7156427"/>
            <a:ext cx="6521383" cy="2339267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>
                    <a:tint val="75000"/>
                  </a:schemeClr>
                </a:solidFill>
              </a:defRPr>
            </a:lvl1pPr>
            <a:lvl2pPr marL="378460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6285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1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15">
                <a:solidFill>
                  <a:schemeClr val="tx1">
                    <a:tint val="75000"/>
                  </a:schemeClr>
                </a:solidFill>
              </a:defRPr>
            </a:lvl5pPr>
            <a:lvl6pPr marL="1890395" indent="0">
              <a:buNone/>
              <a:defRPr sz="1315">
                <a:solidFill>
                  <a:schemeClr val="tx1">
                    <a:tint val="75000"/>
                  </a:schemeClr>
                </a:solidFill>
              </a:defRPr>
            </a:lvl6pPr>
            <a:lvl7pPr marL="2268855" indent="0">
              <a:buNone/>
              <a:defRPr sz="131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15">
                <a:solidFill>
                  <a:schemeClr val="tx1">
                    <a:tint val="75000"/>
                  </a:schemeClr>
                </a:solidFill>
              </a:defRPr>
            </a:lvl8pPr>
            <a:lvl9pPr marL="3025140" indent="0">
              <a:buNone/>
              <a:defRPr sz="131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519821" y="2846728"/>
            <a:ext cx="3213436" cy="678511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827768" y="2846728"/>
            <a:ext cx="3213436" cy="678511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0806" y="569346"/>
            <a:ext cx="6521383" cy="206697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20806" y="2621466"/>
            <a:ext cx="3198668" cy="1284739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460" indent="0">
              <a:buNone/>
              <a:defRPr sz="1655" b="1"/>
            </a:lvl2pPr>
            <a:lvl3pPr marL="756285" indent="0">
              <a:buNone/>
              <a:defRPr sz="1490" b="1"/>
            </a:lvl3pPr>
            <a:lvl4pPr marL="1134110" indent="0">
              <a:buNone/>
              <a:defRPr sz="1315" b="1"/>
            </a:lvl4pPr>
            <a:lvl5pPr marL="1511935" indent="0">
              <a:buNone/>
              <a:defRPr sz="1315" b="1"/>
            </a:lvl5pPr>
            <a:lvl6pPr marL="1890395" indent="0">
              <a:buNone/>
              <a:defRPr sz="1315" b="1"/>
            </a:lvl6pPr>
            <a:lvl7pPr marL="2268855" indent="0">
              <a:buNone/>
              <a:defRPr sz="1315" b="1"/>
            </a:lvl7pPr>
            <a:lvl8pPr marL="2646045" indent="0">
              <a:buNone/>
              <a:defRPr sz="1315" b="1"/>
            </a:lvl8pPr>
            <a:lvl9pPr marL="3025140" indent="0">
              <a:buNone/>
              <a:defRPr sz="131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20806" y="3906205"/>
            <a:ext cx="3198668" cy="574543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827768" y="2621466"/>
            <a:ext cx="3214421" cy="1284739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460" indent="0">
              <a:buNone/>
              <a:defRPr sz="1655" b="1"/>
            </a:lvl2pPr>
            <a:lvl3pPr marL="756285" indent="0">
              <a:buNone/>
              <a:defRPr sz="1490" b="1"/>
            </a:lvl3pPr>
            <a:lvl4pPr marL="1134110" indent="0">
              <a:buNone/>
              <a:defRPr sz="1315" b="1"/>
            </a:lvl4pPr>
            <a:lvl5pPr marL="1511935" indent="0">
              <a:buNone/>
              <a:defRPr sz="1315" b="1"/>
            </a:lvl5pPr>
            <a:lvl6pPr marL="1890395" indent="0">
              <a:buNone/>
              <a:defRPr sz="1315" b="1"/>
            </a:lvl6pPr>
            <a:lvl7pPr marL="2268855" indent="0">
              <a:buNone/>
              <a:defRPr sz="1315" b="1"/>
            </a:lvl7pPr>
            <a:lvl8pPr marL="2646045" indent="0">
              <a:buNone/>
              <a:defRPr sz="1315" b="1"/>
            </a:lvl8pPr>
            <a:lvl9pPr marL="3025140" indent="0">
              <a:buNone/>
              <a:defRPr sz="131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827768" y="3906205"/>
            <a:ext cx="3214421" cy="574543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0806" y="712920"/>
            <a:ext cx="2438627" cy="2495219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214421" y="1539708"/>
            <a:ext cx="3827768" cy="7599524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20806" y="3208138"/>
            <a:ext cx="2438627" cy="5943473"/>
          </a:xfrm>
        </p:spPr>
        <p:txBody>
          <a:bodyPr/>
          <a:lstStyle>
            <a:lvl1pPr marL="0" indent="0">
              <a:buNone/>
              <a:defRPr sz="1315"/>
            </a:lvl1pPr>
            <a:lvl2pPr marL="378460" indent="0">
              <a:buNone/>
              <a:defRPr sz="1160"/>
            </a:lvl2pPr>
            <a:lvl3pPr marL="756285" indent="0">
              <a:buNone/>
              <a:defRPr sz="995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90395" indent="0">
              <a:buNone/>
              <a:defRPr sz="825"/>
            </a:lvl6pPr>
            <a:lvl7pPr marL="2268855" indent="0">
              <a:buNone/>
              <a:defRPr sz="825"/>
            </a:lvl7pPr>
            <a:lvl8pPr marL="2646045" indent="0">
              <a:buNone/>
              <a:defRPr sz="825"/>
            </a:lvl8pPr>
            <a:lvl9pPr marL="3025140" indent="0">
              <a:buNone/>
              <a:defRPr sz="82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0806" y="712920"/>
            <a:ext cx="2438627" cy="2495219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214421" y="1539708"/>
            <a:ext cx="3827768" cy="7599524"/>
          </a:xfrm>
        </p:spPr>
        <p:txBody>
          <a:bodyPr/>
          <a:lstStyle>
            <a:lvl1pPr marL="0" indent="0">
              <a:buNone/>
              <a:defRPr sz="2645"/>
            </a:lvl1pPr>
            <a:lvl2pPr marL="378460" indent="0">
              <a:buNone/>
              <a:defRPr sz="2315"/>
            </a:lvl2pPr>
            <a:lvl3pPr marL="756285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90395" indent="0">
              <a:buNone/>
              <a:defRPr sz="1655"/>
            </a:lvl6pPr>
            <a:lvl7pPr marL="2268855" indent="0">
              <a:buNone/>
              <a:defRPr sz="1655"/>
            </a:lvl7pPr>
            <a:lvl8pPr marL="2646045" indent="0">
              <a:buNone/>
              <a:defRPr sz="1655"/>
            </a:lvl8pPr>
            <a:lvl9pPr marL="3025140" indent="0">
              <a:buNone/>
              <a:defRPr sz="165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20806" y="3208138"/>
            <a:ext cx="2438627" cy="5943473"/>
          </a:xfrm>
        </p:spPr>
        <p:txBody>
          <a:bodyPr/>
          <a:lstStyle>
            <a:lvl1pPr marL="0" indent="0">
              <a:buNone/>
              <a:defRPr sz="1315"/>
            </a:lvl1pPr>
            <a:lvl2pPr marL="378460" indent="0">
              <a:buNone/>
              <a:defRPr sz="1160"/>
            </a:lvl2pPr>
            <a:lvl3pPr marL="756285" indent="0">
              <a:buNone/>
              <a:defRPr sz="995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90395" indent="0">
              <a:buNone/>
              <a:defRPr sz="825"/>
            </a:lvl6pPr>
            <a:lvl7pPr marL="2268855" indent="0">
              <a:buNone/>
              <a:defRPr sz="825"/>
            </a:lvl7pPr>
            <a:lvl8pPr marL="2646045" indent="0">
              <a:buNone/>
              <a:defRPr sz="825"/>
            </a:lvl8pPr>
            <a:lvl9pPr marL="3025140" indent="0">
              <a:buNone/>
              <a:defRPr sz="82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519821" y="569346"/>
            <a:ext cx="6521383" cy="20669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19821" y="2846728"/>
            <a:ext cx="6521383" cy="67851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519821" y="9911562"/>
            <a:ext cx="1701231" cy="5693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504589" y="9911562"/>
            <a:ext cx="2551846" cy="5693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339973" y="9911562"/>
            <a:ext cx="1701231" cy="5693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56285" rtl="0" eaLnBrk="1" latinLnBrk="0" hangingPunct="1">
        <a:lnSpc>
          <a:spcPct val="90000"/>
        </a:lnSpc>
        <a:spcBef>
          <a:spcPct val="0"/>
        </a:spcBef>
        <a:buNone/>
        <a:defRPr sz="36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230" indent="-189230" algn="l" defTabSz="756285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55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3340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700530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2079625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5275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3735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846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628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9039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885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514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6.tiff"/><Relationship Id="rId1" Type="http://schemas.openxmlformats.org/officeDocument/2006/relationships/image" Target="../media/image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916623" y="5646420"/>
            <a:ext cx="5726430" cy="1014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Figure S1. Phylogenetic trees of ALKBHs in tomato,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Arabidopsis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, and human FTO proteins.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Among them, the blue lines and fonts represent the ALKBHs of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Arabidopsis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, the pink lines and fonts represent the ALKBHs of tomato, and the black line represent the human FTO. </a:t>
            </a:r>
            <a:endParaRPr lang="en-US" altLang="zh-CN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5" name="图片 4" descr="figS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64565" y="641985"/>
            <a:ext cx="5629910" cy="483616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915988" y="5304790"/>
            <a:ext cx="5726430" cy="1706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Figure S2. Effects of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SlALKBH2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,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SlALKBH8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,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SlALKBH9A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, and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SlALKBH9B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on drought-induced flower drop. (A)-(D)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Analysis of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lALKBH9B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,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LKBH2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,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LKBH8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,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and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LKBH9A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 expression in silenced and pTRV2-empty plants. Results represent the mean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±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SD of three replicates. (ANOVA in one-way using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Š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í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d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á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k’s test: ****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&lt; 0.0001).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(E)-(H)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Flower drop rate of silenced lines during drought. The result is ensured that the experimental represent the average of three repetitions (One-way ANOVA with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Š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í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d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á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k’s test: ns, no significant difference; *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&lt; 0.05; **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&lt; 0.01).</a:t>
            </a:r>
            <a:endParaRPr lang="en-US" altLang="zh-CN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figS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15975" y="814705"/>
            <a:ext cx="5927725" cy="446214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figS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09663" y="631190"/>
            <a:ext cx="5340350" cy="462978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916623" y="5304790"/>
            <a:ext cx="5726430" cy="1938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Figure S3. Identification of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SlALKBH9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B gene-edited and overexpressed plants. (A)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The sgRNA targets are displayed on top of a schematic representation of the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LKBH9B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gene, and on the bottom are the gene’s DNA sequence and the anticipated protein sequences of the WT and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lkbh9b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strains. Deletions are represented by the blue hyphen. Black stated that the red text sgRNA targets in the figure represent the protospacer-adjacent motif (PAM).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(B)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The AZ of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LKBH9B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-OE and WT plants’ relative expression of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LKBH9B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. ANOVA in one-way using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Š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í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d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á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k’s test: ****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P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&lt; 0.0001; values are mean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±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SD.</a:t>
            </a:r>
            <a:endParaRPr lang="en-US" altLang="zh-CN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4" name="组合 3"/>
          <p:cNvGrpSpPr/>
          <p:nvPr/>
        </p:nvGrpSpPr>
        <p:grpSpPr>
          <a:xfrm>
            <a:off x="891858" y="998220"/>
            <a:ext cx="5775960" cy="5718175"/>
            <a:chOff x="1524" y="6512"/>
            <a:chExt cx="9096" cy="9005"/>
          </a:xfrm>
        </p:grpSpPr>
        <p:sp>
          <p:nvSpPr>
            <p:cNvPr id="3" name="文本框 2"/>
            <p:cNvSpPr txBox="1"/>
            <p:nvPr/>
          </p:nvSpPr>
          <p:spPr>
            <a:xfrm>
              <a:off x="1564" y="12465"/>
              <a:ext cx="9018" cy="30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just">
                <a:lnSpc>
                  <a:spcPct val="12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Figure S4. Variations in methylome between Slalkbh9b and WT. (A) 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Displayed in the Venn diagram are the common m6A peaks from m6A-seq experiments for the AZ of WT and Slalkbh9b plants during drought, which were employed for further analysis. Slalkbh9b had increased or decreased amounts of m6A-modified transcripts compared to WT. 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(B)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 m6A peaks in the mRNA transcription function area distribution (CDS, 5′ UTR, 3′ UTR, TSS, and stop codon area). 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(C)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 Different m6A peak number accounts for the percentage of m6A transcript. 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(D) 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Sequence motifs identified within the m6A peaks by HOMER.</a:t>
              </a:r>
              <a:endParaRPr lang="en-US" altLang="zh-CN" sz="120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6" name="图片 5" descr="figS4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1524" y="6512"/>
              <a:ext cx="9097" cy="5649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916623" y="3951605"/>
            <a:ext cx="5726430" cy="321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Figure S5.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KEGG classification of assembled DEGs (25 DEGs). </a:t>
            </a:r>
            <a:endParaRPr lang="en-US" altLang="zh-CN"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" name="图片 2" descr="figS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41450" y="694690"/>
            <a:ext cx="4676775" cy="309054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916623" y="7628890"/>
            <a:ext cx="5726430" cy="1014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Figure S6.  The relative expression of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SlETO1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in various parts of tomato plants using RT-qPCR under both normal and drought conditions.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The data is the mean of three replicates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±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standard deviation (SD). Significant differences were identified through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two-way ANOVA with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Ší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d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á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k’s test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: ns, no significant difference; *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&lt; 0.05; ****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&lt; 0.0001.</a:t>
            </a:r>
            <a:endParaRPr lang="zh-CN" alt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FigS6-干旱下ETO1各部位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5418" y="5808345"/>
            <a:ext cx="2148840" cy="183769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2" name="图片 11" descr="figS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231265" y="670560"/>
            <a:ext cx="5097145" cy="257048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916623" y="3388360"/>
            <a:ext cx="5726430" cy="124523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Figure S7. Identification of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SlETO1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gene-edited plants.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The sgRNA targets are displayed on top of a schematic representation of the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ETO1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gene. On the bottom, however, are the gene’s DNA sequence and the anticipated protein sequences of the WT and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ETO1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mutant strains. Deletions are represented by blue hyphens. Black stated that the red text sgRNA targets in the figure represent the protospacer-adjacent motif (PAM).</a:t>
            </a:r>
            <a:endParaRPr lang="en-US" altLang="zh-CN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916623" y="5376545"/>
            <a:ext cx="5726430" cy="3015615"/>
            <a:chOff x="1444" y="9031"/>
            <a:chExt cx="9018" cy="4749"/>
          </a:xfrm>
        </p:grpSpPr>
        <p:pic>
          <p:nvPicPr>
            <p:cNvPr id="9" name="图片 8" descr="figS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76" y="9031"/>
              <a:ext cx="3353" cy="2991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1444" y="12182"/>
              <a:ext cx="9018" cy="15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just">
                <a:lnSpc>
                  <a:spcPct val="12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Figure S8. The relative expression of </a:t>
              </a:r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SlACS3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and </a:t>
              </a:r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SlACS8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in tomato AZ of WT with or without drought treatment was examined using RT-qPCR.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 The data are represented as the three replicates’ mean </a:t>
              </a:r>
              <a:r>
                <a:rPr lang="en-US" altLang="en-US" sz="1200">
                  <a:latin typeface="Times New Roman" panose="02020603050405020304" charset="0"/>
                  <a:cs typeface="Times New Roman" panose="02020603050405020304" charset="0"/>
                </a:rPr>
                <a:t>±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 SD. Two-way ANOVA using </a:t>
              </a:r>
              <a:r>
                <a:rPr lang="en-US" altLang="en-US" sz="1200">
                  <a:latin typeface="Times New Roman" panose="02020603050405020304" charset="0"/>
                  <a:cs typeface="Times New Roman" panose="02020603050405020304" charset="0"/>
                </a:rPr>
                <a:t>Š</a:t>
              </a:r>
              <a:r>
                <a:rPr lang="en-US" altLang="en-US" sz="1200">
                  <a:latin typeface="Times New Roman" panose="02020603050405020304" charset="0"/>
                  <a:cs typeface="Times New Roman" panose="02020603050405020304" charset="0"/>
                </a:rPr>
                <a:t>í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d</a:t>
              </a:r>
              <a:r>
                <a:rPr lang="en-US" altLang="en-US" sz="1200">
                  <a:latin typeface="Times New Roman" panose="02020603050405020304" charset="0"/>
                  <a:cs typeface="Times New Roman" panose="02020603050405020304" charset="0"/>
                </a:rPr>
                <a:t>á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k’s test was used to analyze the significant difference (**</a:t>
              </a:r>
              <a:r>
                <a:rPr lang="en-US" altLang="zh-CN" sz="1200" i="1">
                  <a:latin typeface="Times New Roman" panose="02020603050405020304" charset="0"/>
                  <a:cs typeface="Times New Roman" panose="02020603050405020304" charset="0"/>
                </a:rPr>
                <a:t>P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 &lt; 0.01; ***</a:t>
              </a:r>
              <a:r>
                <a:rPr lang="en-US" altLang="zh-CN" sz="1200" i="1">
                  <a:latin typeface="Times New Roman" panose="02020603050405020304" charset="0"/>
                  <a:cs typeface="Times New Roman" panose="02020603050405020304" charset="0"/>
                </a:rPr>
                <a:t>P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 &lt; 0.001).</a:t>
              </a:r>
              <a:endParaRPr lang="en-US" altLang="zh-CN" sz="120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3" name="文本框 12"/>
          <p:cNvSpPr txBox="1"/>
          <p:nvPr/>
        </p:nvSpPr>
        <p:spPr>
          <a:xfrm>
            <a:off x="916623" y="6797040"/>
            <a:ext cx="5726430" cy="28613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Figure S9. Expression of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SlACS3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and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SlACS8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in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SlACS3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and </a:t>
            </a:r>
            <a:r>
              <a:rPr lang="en-US" altLang="zh-CN" sz="1200" b="1" i="1">
                <a:latin typeface="Times New Roman" panose="02020603050405020304" charset="0"/>
                <a:cs typeface="Times New Roman" panose="02020603050405020304" charset="0"/>
              </a:rPr>
              <a:t>8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silenced plants. (A)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and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(D)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Examination of the expression of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CS3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and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CS8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in pTRV2-empty and silenced plants. The mean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±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SD of three replicates is shown in the results. One-way ANOVA using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Š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í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d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á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k’s test: ****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P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&lt;0.0001.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(B)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and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(E)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Drought-induced flower drop rate in silenced lines.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Š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í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d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á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k’s test (one-way ANOVA) is used to ensure that the experimental results represent the average of three times (*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&lt;0.05).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(C)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and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(F)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Ethylene production of AZ after silencing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CS3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and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CS8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, respectively. *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&lt;0.05; values are mean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±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SD (three times),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Š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í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d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á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k’s test (one-way ANOVA).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(G)-(I)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SlACS3 and SlACS8 expression levels were simultaneously reduced in WT,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Slalkbh9b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and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 Sleto1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. The values are the averages of three different pools of AZs from different plants, with standard deviations (SD) included. A two-way ANOVA with 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Š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í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d</a:t>
            </a:r>
            <a:r>
              <a:rPr lang="en-US" altLang="en-US" sz="1200">
                <a:latin typeface="Times New Roman" panose="02020603050405020304" charset="0"/>
                <a:cs typeface="Times New Roman" panose="02020603050405020304" charset="0"/>
              </a:rPr>
              <a:t>á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k’s test was used to identify significant differences: ****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&lt; 0.0001.</a:t>
            </a:r>
            <a:endParaRPr lang="en-US" altLang="zh-CN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" name="图片 2" descr="figS9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79780" y="775335"/>
            <a:ext cx="5896610" cy="602170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78</Words>
  <Application>WPS 演示</Application>
  <PresentationFormat>宽屏</PresentationFormat>
  <Paragraphs>18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瘦.蔡</dc:creator>
  <cp:lastModifiedBy>cy</cp:lastModifiedBy>
  <cp:revision>58</cp:revision>
  <dcterms:created xsi:type="dcterms:W3CDTF">2023-08-09T12:44:00Z</dcterms:created>
  <dcterms:modified xsi:type="dcterms:W3CDTF">2025-05-30T02:22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FC7CA33F1CA45CB8B098984A2CA1D85_13</vt:lpwstr>
  </property>
  <property fmtid="{D5CDD505-2E9C-101B-9397-08002B2CF9AE}" pid="3" name="KSOProductBuildVer">
    <vt:lpwstr>2052-12.1.0.21171</vt:lpwstr>
  </property>
</Properties>
</file>